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59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2628" y="-1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hD\PhD_all\PhD%20thesis\Chapter%205%20(Vib%20Trial)\Working\Pain\Done\Pain%20-%20What%20is%20your%20current%20level%20of%20activity%20at%20work%202%20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hD\PhD_all\PhD%20thesis\Chapter%205%20(Vib%20Trial)\Working\Pain\Done\Pain%20-%20What%20is%20your%20current%20level%20of%20activity%20at%20work%202%20a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H:\PhD\PhD%20-%20Working%20folder\Working\Pain\Done\Pain%20-%20How%20much%20difficulty%20do%20you%20have%20with%20activites%20above%20your%20hea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AU"/>
  <c:chart>
    <c:autoTitleDeleted val="1"/>
    <c:plotArea>
      <c:layout>
        <c:manualLayout>
          <c:layoutTarget val="inner"/>
          <c:xMode val="edge"/>
          <c:yMode val="edge"/>
          <c:x val="0.18490059055118122"/>
          <c:y val="2.9057064439229587E-2"/>
          <c:w val="0.78691185476815395"/>
          <c:h val="0.80838484157651169"/>
        </c:manualLayout>
      </c:layout>
      <c:lineChart>
        <c:grouping val="standard"/>
        <c:ser>
          <c:idx val="0"/>
          <c:order val="0"/>
          <c:tx>
            <c:strRef>
              <c:f>Sheet1!$S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  <a:prstDash val="solid"/>
            </a:ln>
          </c:spPr>
          <c:errBars>
            <c:errDir val="y"/>
            <c:errBarType val="both"/>
            <c:errValType val="cust"/>
            <c:pl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050571291838439</c:v>
                  </c:pt>
                  <c:pt idx="1">
                    <c:v>4.4255719836307682E-2</c:v>
                  </c:pt>
                  <c:pt idx="2">
                    <c:v>0.10272267545166484</c:v>
                  </c:pt>
                  <c:pt idx="3">
                    <c:v>0.10280730213809135</c:v>
                  </c:pt>
                  <c:pt idx="4">
                    <c:v>0.1058823529411765</c:v>
                  </c:pt>
                </c:numCache>
              </c:numRef>
            </c:plus>
            <c:min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050571291838439</c:v>
                  </c:pt>
                  <c:pt idx="1">
                    <c:v>4.4255719836307682E-2</c:v>
                  </c:pt>
                  <c:pt idx="2">
                    <c:v>0.10272267545166484</c:v>
                  </c:pt>
                  <c:pt idx="3">
                    <c:v>0.10280730213809135</c:v>
                  </c:pt>
                  <c:pt idx="4">
                    <c:v>0.1058823529411765</c:v>
                  </c:pt>
                </c:numCache>
              </c:numRef>
            </c:minus>
            <c:spPr>
              <a:ln>
                <a:solidFill>
                  <a:srgbClr val="0070C0"/>
                </a:solidFill>
              </a:ln>
            </c:spPr>
          </c:errBars>
          <c:cat>
            <c:numRef>
              <c:f>(Sheet1!$S$2,Sheet1!$V$2,Sheet1!$Y$2,Sheet1!$AB$2,Sheet1!$AE$2)</c:f>
              <c:numCache>
                <c:formatCode>General</c:formatCode>
                <c:ptCount val="5"/>
                <c:pt idx="0">
                  <c:v>-9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numCache>
            </c:numRef>
          </c:cat>
          <c:val>
            <c:numRef>
              <c:f>(Sheet1!$S$69,Sheet1!$V$69,Sheet1!$Y$69,Sheet1!$AB$69,Sheet1!$AE$69)</c:f>
              <c:numCache>
                <c:formatCode>0.00</c:formatCode>
                <c:ptCount val="5"/>
                <c:pt idx="0">
                  <c:v>0.93548387096774166</c:v>
                </c:pt>
                <c:pt idx="1">
                  <c:v>0.13333333333333339</c:v>
                </c:pt>
                <c:pt idx="2">
                  <c:v>0.75000000000000022</c:v>
                </c:pt>
                <c:pt idx="3">
                  <c:v>0.91071428571428559</c:v>
                </c:pt>
                <c:pt idx="4">
                  <c:v>1.294117647058824</c:v>
                </c:pt>
              </c:numCache>
            </c:numRef>
          </c:val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marker>
            <c:spPr>
              <a:solidFill>
                <a:srgbClr val="92D050"/>
              </a:solidFill>
              <a:ln>
                <a:solidFill>
                  <a:srgbClr val="92D05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1684413735278239</c:v>
                  </c:pt>
                  <c:pt idx="1">
                    <c:v>5.4175354188514505E-2</c:v>
                  </c:pt>
                  <c:pt idx="2">
                    <c:v>8.7333376460937279E-2</c:v>
                  </c:pt>
                  <c:pt idx="3">
                    <c:v>0.1041584350489039</c:v>
                  </c:pt>
                  <c:pt idx="4">
                    <c:v>0.11069354644463159</c:v>
                  </c:pt>
                </c:numCache>
              </c:numRef>
            </c:plus>
            <c:min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1684413735278239</c:v>
                  </c:pt>
                  <c:pt idx="1">
                    <c:v>5.4175354188514505E-2</c:v>
                  </c:pt>
                  <c:pt idx="2">
                    <c:v>8.7333376460937279E-2</c:v>
                  </c:pt>
                  <c:pt idx="3">
                    <c:v>0.1041584350489039</c:v>
                  </c:pt>
                  <c:pt idx="4">
                    <c:v>0.11069354644463159</c:v>
                  </c:pt>
                </c:numCache>
              </c:numRef>
            </c:minus>
            <c:spPr>
              <a:ln>
                <a:solidFill>
                  <a:srgbClr val="92D050"/>
                </a:solidFill>
              </a:ln>
            </c:spPr>
          </c:errBars>
          <c:val>
            <c:numRef>
              <c:f>(Sheet1!$T$69,Sheet1!$W$69,Sheet1!$Z$69,Sheet1!$AC$69,Sheet1!$AF$69)</c:f>
              <c:numCache>
                <c:formatCode>0.00</c:formatCode>
                <c:ptCount val="5"/>
                <c:pt idx="0">
                  <c:v>1.1578947368421049</c:v>
                </c:pt>
                <c:pt idx="1">
                  <c:v>0.10526315789473686</c:v>
                </c:pt>
                <c:pt idx="2">
                  <c:v>0.5</c:v>
                </c:pt>
                <c:pt idx="3">
                  <c:v>0.78</c:v>
                </c:pt>
                <c:pt idx="4">
                  <c:v>1.1399999999999995</c:v>
                </c:pt>
              </c:numCache>
            </c:numRef>
          </c:val>
        </c:ser>
        <c:marker val="1"/>
        <c:axId val="81432960"/>
        <c:axId val="81434880"/>
      </c:lineChart>
      <c:catAx>
        <c:axId val="8143296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Weeks after Rotator Cuff Repair</a:t>
                </a:r>
              </a:p>
            </c:rich>
          </c:tx>
          <c:layout>
            <c:manualLayout>
              <c:xMode val="edge"/>
              <c:yMode val="edge"/>
              <c:x val="0.35798151793525829"/>
              <c:y val="0.91456031423127493"/>
            </c:manualLayout>
          </c:layout>
        </c:title>
        <c:numFmt formatCode="General" sourceLinked="1"/>
        <c:maj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1434880"/>
        <c:crosses val="autoZero"/>
        <c:auto val="1"/>
        <c:lblAlgn val="ctr"/>
        <c:lblOffset val="100"/>
      </c:catAx>
      <c:valAx>
        <c:axId val="81434880"/>
        <c:scaling>
          <c:orientation val="minMax"/>
          <c:max val="3"/>
        </c:scaling>
        <c:axPos val="l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Level of Activities at Work</a:t>
                </a:r>
              </a:p>
            </c:rich>
          </c:tx>
          <c:layout>
            <c:manualLayout>
              <c:xMode val="edge"/>
              <c:yMode val="edge"/>
              <c:x val="2.0833333333333346E-2"/>
              <c:y val="0.21098637975769444"/>
            </c:manualLayout>
          </c:layout>
        </c:title>
        <c:numFmt formatCode="0.00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1432960"/>
        <c:crosses val="autoZero"/>
        <c:crossBetween val="between"/>
        <c:majorUnit val="1"/>
        <c:minorUnit val="1"/>
      </c:valAx>
    </c:plotArea>
    <c:legend>
      <c:legendPos val="r"/>
      <c:layout>
        <c:manualLayout>
          <c:xMode val="edge"/>
          <c:yMode val="edge"/>
          <c:x val="0.84542355643044631"/>
          <c:y val="4.4739341016801257E-2"/>
          <c:w val="0.1351319991251094"/>
          <c:h val="9.9715867886005061E-2"/>
        </c:manualLayout>
      </c:layout>
      <c:txPr>
        <a:bodyPr/>
        <a:lstStyle/>
        <a:p>
          <a:pPr>
            <a:defRPr sz="1600"/>
          </a:pPr>
          <a:endParaRPr lang="en-US"/>
        </a:p>
      </c:txPr>
    </c:legend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AU"/>
  <c:chart>
    <c:autoTitleDeleted val="1"/>
    <c:plotArea>
      <c:layout>
        <c:manualLayout>
          <c:layoutTarget val="inner"/>
          <c:xMode val="edge"/>
          <c:yMode val="edge"/>
          <c:x val="0.18490059055118133"/>
          <c:y val="2.9057064439229601E-2"/>
          <c:w val="0.78691185476815395"/>
          <c:h val="0.80838484157651169"/>
        </c:manualLayout>
      </c:layout>
      <c:lineChart>
        <c:grouping val="standard"/>
        <c:ser>
          <c:idx val="0"/>
          <c:order val="0"/>
          <c:tx>
            <c:strRef>
              <c:f>Sheet1!$S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  <a:prstDash val="solid"/>
            </a:ln>
          </c:spPr>
          <c:errBars>
            <c:errDir val="y"/>
            <c:errBarType val="both"/>
            <c:errValType val="cust"/>
            <c:pl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050571291838439</c:v>
                  </c:pt>
                  <c:pt idx="1">
                    <c:v>4.4255719836307703E-2</c:v>
                  </c:pt>
                  <c:pt idx="2">
                    <c:v>0.10272267545166493</c:v>
                  </c:pt>
                  <c:pt idx="3">
                    <c:v>0.10280730213809135</c:v>
                  </c:pt>
                  <c:pt idx="4">
                    <c:v>0.10588235294117652</c:v>
                  </c:pt>
                </c:numCache>
              </c:numRef>
            </c:plus>
            <c:min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050571291838439</c:v>
                  </c:pt>
                  <c:pt idx="1">
                    <c:v>4.4255719836307703E-2</c:v>
                  </c:pt>
                  <c:pt idx="2">
                    <c:v>0.10272267545166493</c:v>
                  </c:pt>
                  <c:pt idx="3">
                    <c:v>0.10280730213809135</c:v>
                  </c:pt>
                  <c:pt idx="4">
                    <c:v>0.10588235294117652</c:v>
                  </c:pt>
                </c:numCache>
              </c:numRef>
            </c:minus>
            <c:spPr>
              <a:ln>
                <a:solidFill>
                  <a:srgbClr val="0070C0"/>
                </a:solidFill>
              </a:ln>
            </c:spPr>
          </c:errBars>
          <c:cat>
            <c:numRef>
              <c:f>(Sheet1!$S$2,Sheet1!$V$2,Sheet1!$Y$2,Sheet1!$AB$2,Sheet1!$AE$2)</c:f>
              <c:numCache>
                <c:formatCode>General</c:formatCode>
                <c:ptCount val="5"/>
                <c:pt idx="0">
                  <c:v>-9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numCache>
            </c:numRef>
          </c:cat>
          <c:val>
            <c:numRef>
              <c:f>(Sheet1!$S$69,Sheet1!$V$69,Sheet1!$Y$69,Sheet1!$AB$69,Sheet1!$AE$69)</c:f>
              <c:numCache>
                <c:formatCode>0.00</c:formatCode>
                <c:ptCount val="5"/>
                <c:pt idx="0">
                  <c:v>0.93548387096774144</c:v>
                </c:pt>
                <c:pt idx="1">
                  <c:v>0.13333333333333341</c:v>
                </c:pt>
                <c:pt idx="2">
                  <c:v>0.75000000000000044</c:v>
                </c:pt>
                <c:pt idx="3">
                  <c:v>0.91071428571428559</c:v>
                </c:pt>
                <c:pt idx="4">
                  <c:v>1.294117647058824</c:v>
                </c:pt>
              </c:numCache>
            </c:numRef>
          </c:val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errBars>
            <c:errDir val="y"/>
            <c:errBarType val="both"/>
            <c:errValType val="cust"/>
            <c:pl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1684413735278237</c:v>
                  </c:pt>
                  <c:pt idx="1">
                    <c:v>5.4175354188514505E-2</c:v>
                  </c:pt>
                  <c:pt idx="2">
                    <c:v>8.7333376460937279E-2</c:v>
                  </c:pt>
                  <c:pt idx="3">
                    <c:v>0.1041584350489039</c:v>
                  </c:pt>
                  <c:pt idx="4">
                    <c:v>0.11069354644463163</c:v>
                  </c:pt>
                </c:numCache>
              </c:numRef>
            </c:plus>
            <c:min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1684413735278237</c:v>
                  </c:pt>
                  <c:pt idx="1">
                    <c:v>5.4175354188514505E-2</c:v>
                  </c:pt>
                  <c:pt idx="2">
                    <c:v>8.7333376460937279E-2</c:v>
                  </c:pt>
                  <c:pt idx="3">
                    <c:v>0.1041584350489039</c:v>
                  </c:pt>
                  <c:pt idx="4">
                    <c:v>0.11069354644463163</c:v>
                  </c:pt>
                </c:numCache>
              </c:numRef>
            </c:minus>
            <c:spPr>
              <a:ln>
                <a:solidFill>
                  <a:srgbClr val="92D050"/>
                </a:solidFill>
              </a:ln>
            </c:spPr>
          </c:errBars>
          <c:val>
            <c:numRef>
              <c:f>(Sheet1!$T$69,Sheet1!$W$69,Sheet1!$Z$69,Sheet1!$AC$69,Sheet1!$AF$69)</c:f>
              <c:numCache>
                <c:formatCode>0.00</c:formatCode>
                <c:ptCount val="5"/>
                <c:pt idx="0">
                  <c:v>1.1578947368421044</c:v>
                </c:pt>
                <c:pt idx="1">
                  <c:v>0.10526315789473686</c:v>
                </c:pt>
                <c:pt idx="2">
                  <c:v>0.5</c:v>
                </c:pt>
                <c:pt idx="3">
                  <c:v>0.78</c:v>
                </c:pt>
                <c:pt idx="4">
                  <c:v>1.139999999999999</c:v>
                </c:pt>
              </c:numCache>
            </c:numRef>
          </c:val>
        </c:ser>
        <c:marker val="1"/>
        <c:axId val="82669568"/>
        <c:axId val="82671488"/>
      </c:lineChart>
      <c:catAx>
        <c:axId val="8266956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Weeks after Rotator Cuff Repair</a:t>
                </a:r>
              </a:p>
            </c:rich>
          </c:tx>
          <c:layout>
            <c:manualLayout>
              <c:xMode val="edge"/>
              <c:yMode val="edge"/>
              <c:x val="0.35798151793525856"/>
              <c:y val="0.91456031423127471"/>
            </c:manualLayout>
          </c:layout>
        </c:title>
        <c:numFmt formatCode="General" sourceLinked="1"/>
        <c:maj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2671488"/>
        <c:crosses val="autoZero"/>
        <c:auto val="1"/>
        <c:lblAlgn val="ctr"/>
        <c:lblOffset val="100"/>
      </c:catAx>
      <c:valAx>
        <c:axId val="82671488"/>
        <c:scaling>
          <c:orientation val="minMax"/>
          <c:max val="3"/>
        </c:scaling>
        <c:axPos val="l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Level of Activities at Work</a:t>
                </a:r>
              </a:p>
            </c:rich>
          </c:tx>
          <c:layout>
            <c:manualLayout>
              <c:xMode val="edge"/>
              <c:yMode val="edge"/>
              <c:x val="2.0833333333333356E-2"/>
              <c:y val="0.21098637975769449"/>
            </c:manualLayout>
          </c:layout>
        </c:title>
        <c:numFmt formatCode="0.00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2669568"/>
        <c:crosses val="autoZero"/>
        <c:crossBetween val="between"/>
        <c:majorUnit val="1"/>
        <c:minorUnit val="1"/>
      </c:valAx>
    </c:plotArea>
    <c:legend>
      <c:legendPos val="r"/>
      <c:layout>
        <c:manualLayout>
          <c:xMode val="edge"/>
          <c:yMode val="edge"/>
          <c:x val="0.83986800087489111"/>
          <c:y val="2.3091622689412145E-2"/>
          <c:w val="0.1351319991251094"/>
          <c:h val="9.9715867886005088E-2"/>
        </c:manualLayout>
      </c:layout>
      <c:txPr>
        <a:bodyPr/>
        <a:lstStyle/>
        <a:p>
          <a:pPr>
            <a:defRPr sz="1600"/>
          </a:pPr>
          <a:endParaRPr lang="en-US"/>
        </a:p>
      </c:txPr>
    </c:legend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AU"/>
  <c:chart>
    <c:autoTitleDeleted val="1"/>
    <c:plotArea>
      <c:layout>
        <c:manualLayout>
          <c:layoutTarget val="inner"/>
          <c:xMode val="edge"/>
          <c:yMode val="edge"/>
          <c:x val="0.21927756020740619"/>
          <c:y val="0.19503178769320509"/>
          <c:w val="0.70073852498521849"/>
          <c:h val="0.67244065325167857"/>
        </c:manualLayout>
      </c:layout>
      <c:lineChart>
        <c:grouping val="standard"/>
        <c:ser>
          <c:idx val="0"/>
          <c:order val="0"/>
          <c:tx>
            <c:strRef>
              <c:f>Sheet1!$S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  <a:prstDash val="solid"/>
            </a:ln>
          </c:spPr>
          <c:errBars>
            <c:errDir val="y"/>
            <c:errBarType val="both"/>
            <c:errValType val="cust"/>
            <c:pl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908209629527556</c:v>
                  </c:pt>
                  <c:pt idx="1">
                    <c:v>0.16207722149701634</c:v>
                  </c:pt>
                  <c:pt idx="2">
                    <c:v>0.18538488297990471</c:v>
                  </c:pt>
                  <c:pt idx="3">
                    <c:v>0.16524355544590549</c:v>
                  </c:pt>
                  <c:pt idx="4">
                    <c:v>0.14292949787065543</c:v>
                  </c:pt>
                </c:numCache>
              </c:numRef>
            </c:plus>
            <c:min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908209629527556</c:v>
                  </c:pt>
                  <c:pt idx="1">
                    <c:v>0.16207722149701634</c:v>
                  </c:pt>
                  <c:pt idx="2">
                    <c:v>0.18538488297990471</c:v>
                  </c:pt>
                  <c:pt idx="3">
                    <c:v>0.16524355544590549</c:v>
                  </c:pt>
                  <c:pt idx="4">
                    <c:v>0.14292949787065543</c:v>
                  </c:pt>
                </c:numCache>
              </c:numRef>
            </c:minus>
          </c:errBars>
          <c:cat>
            <c:numRef>
              <c:f>(Sheet1!$S$2,Sheet1!$V$2,Sheet1!$Y$2,Sheet1!$AB$2,Sheet1!$AE$2)</c:f>
              <c:numCache>
                <c:formatCode>General</c:formatCode>
                <c:ptCount val="5"/>
                <c:pt idx="0">
                  <c:v>-1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numCache>
            </c:numRef>
          </c:cat>
          <c:val>
            <c:numRef>
              <c:f>(Sheet1!$S$69,Sheet1!$V$69,Sheet1!$Y$69,Sheet1!$AB$69,Sheet1!$AE$69)</c:f>
              <c:numCache>
                <c:formatCode>0.00</c:formatCode>
                <c:ptCount val="5"/>
                <c:pt idx="0">
                  <c:v>3.0163934426229546</c:v>
                </c:pt>
                <c:pt idx="1">
                  <c:v>3.6744186046511627</c:v>
                </c:pt>
                <c:pt idx="2">
                  <c:v>2.7924528301886746</c:v>
                </c:pt>
                <c:pt idx="3">
                  <c:v>2.1851851851851847</c:v>
                </c:pt>
                <c:pt idx="4">
                  <c:v>1.7358490566037739</c:v>
                </c:pt>
              </c:numCache>
            </c:numRef>
          </c:val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marker>
            <c:spPr>
              <a:solidFill>
                <a:srgbClr val="92D050"/>
              </a:solidFill>
              <a:ln>
                <a:solidFill>
                  <a:srgbClr val="92D05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4843897105039314</c:v>
                  </c:pt>
                  <c:pt idx="1">
                    <c:v>0.13913064518828042</c:v>
                  </c:pt>
                  <c:pt idx="2">
                    <c:v>0.14562279831062711</c:v>
                  </c:pt>
                  <c:pt idx="3">
                    <c:v>0.14509803921568626</c:v>
                  </c:pt>
                  <c:pt idx="4">
                    <c:v>0.16526515690749441</c:v>
                  </c:pt>
                </c:numCache>
              </c:numRef>
            </c:plus>
            <c:min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4843897105039314</c:v>
                  </c:pt>
                  <c:pt idx="1">
                    <c:v>0.13913064518828042</c:v>
                  </c:pt>
                  <c:pt idx="2">
                    <c:v>0.14562279831062711</c:v>
                  </c:pt>
                  <c:pt idx="3">
                    <c:v>0.14509803921568626</c:v>
                  </c:pt>
                  <c:pt idx="4">
                    <c:v>0.16526515690749441</c:v>
                  </c:pt>
                </c:numCache>
              </c:numRef>
            </c:minus>
          </c:errBars>
          <c:val>
            <c:numRef>
              <c:f>(Sheet1!$T$69,Sheet1!$W$69,Sheet1!$Z$69,Sheet1!$AC$69,Sheet1!$AF$69)</c:f>
              <c:numCache>
                <c:formatCode>0.00</c:formatCode>
                <c:ptCount val="5"/>
                <c:pt idx="0">
                  <c:v>3.0517241379310351</c:v>
                </c:pt>
                <c:pt idx="1">
                  <c:v>3.6666666666666665</c:v>
                </c:pt>
                <c:pt idx="2">
                  <c:v>3.0181818181818212</c:v>
                </c:pt>
                <c:pt idx="3">
                  <c:v>2.2549019607843181</c:v>
                </c:pt>
                <c:pt idx="4">
                  <c:v>1.6470588235294121</c:v>
                </c:pt>
              </c:numCache>
            </c:numRef>
          </c:val>
        </c:ser>
        <c:marker val="1"/>
        <c:axId val="84532608"/>
        <c:axId val="82576896"/>
      </c:lineChart>
      <c:catAx>
        <c:axId val="8453260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 baseline="0"/>
                </a:pPr>
                <a:r>
                  <a:rPr lang="en-US" sz="2000" baseline="0" dirty="0"/>
                  <a:t>Weeks after Rotator Cuff Repair</a:t>
                </a:r>
              </a:p>
            </c:rich>
          </c:tx>
          <c:layout>
            <c:manualLayout>
              <c:xMode val="edge"/>
              <c:yMode val="edge"/>
              <c:x val="0.35077073790657581"/>
              <c:y val="0.919879556722077"/>
            </c:manualLayout>
          </c:layout>
        </c:title>
        <c:numFmt formatCode="General" sourceLinked="1"/>
        <c:maj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 baseline="0"/>
            </a:pPr>
            <a:endParaRPr lang="en-US"/>
          </a:p>
        </c:txPr>
        <c:crossAx val="82576896"/>
        <c:crosses val="autoZero"/>
        <c:auto val="1"/>
        <c:lblAlgn val="ctr"/>
        <c:lblOffset val="100"/>
      </c:catAx>
      <c:valAx>
        <c:axId val="82576896"/>
        <c:scaling>
          <c:orientation val="minMax"/>
          <c:max val="4"/>
        </c:scaling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sz="2000" b="1" i="0" baseline="0" dirty="0"/>
                  <a:t>Difficulty with Overhead </a:t>
                </a:r>
                <a:r>
                  <a:rPr lang="en-AU" sz="2000" b="1" i="0" baseline="0" dirty="0" smtClean="0"/>
                  <a:t>Activities</a:t>
                </a:r>
                <a:endParaRPr lang="en-AU" sz="2000" baseline="0" dirty="0"/>
              </a:p>
            </c:rich>
          </c:tx>
          <c:layout>
            <c:manualLayout>
              <c:xMode val="edge"/>
              <c:yMode val="edge"/>
              <c:x val="4.707514635965631E-2"/>
              <c:y val="0.24596704578594369"/>
            </c:manualLayout>
          </c:layout>
        </c:title>
        <c:numFmt formatCode="0.00" sourceLinked="1"/>
        <c:tickLblPos val="nextTo"/>
        <c:spPr>
          <a:ln w="25400">
            <a:solidFill>
              <a:schemeClr val="tx1"/>
            </a:solidFill>
          </a:ln>
        </c:spPr>
        <c:crossAx val="84532608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79874455224257579"/>
          <c:y val="0.16419510061242373"/>
          <c:w val="0.13476823983733371"/>
          <c:h val="9.3832020997375518E-2"/>
        </c:manualLayout>
      </c:layout>
      <c:txPr>
        <a:bodyPr/>
        <a:lstStyle/>
        <a:p>
          <a:pPr>
            <a:defRPr sz="1600" baseline="0"/>
          </a:pPr>
          <a:endParaRPr lang="en-US"/>
        </a:p>
      </c:txPr>
    </c:legend>
    <c:plotVisOnly val="1"/>
  </c:chart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851</cdr:x>
      <cdr:y>0.12201</cdr:y>
    </cdr:from>
    <cdr:to>
      <cdr:x>0.22248</cdr:x>
      <cdr:y>0.91991</cdr:y>
    </cdr:to>
    <cdr:grpSp>
      <cdr:nvGrpSpPr>
        <cdr:cNvPr id="9" name="Group 8"/>
        <cdr:cNvGrpSpPr/>
      </cdr:nvGrpSpPr>
      <cdr:grpSpPr>
        <a:xfrm xmlns:a="http://schemas.openxmlformats.org/drawingml/2006/main">
          <a:off x="780255" y="836745"/>
          <a:ext cx="1259593" cy="5471998"/>
          <a:chOff x="5508104" y="980728"/>
          <a:chExt cx="1259632" cy="5400600"/>
        </a:xfrm>
      </cdr:grpSpPr>
      <cdr:sp macro="" textlink="">
        <cdr:nvSpPr>
          <cdr:cNvPr id="10" name="Rectangle 9"/>
          <cdr:cNvSpPr/>
        </cdr:nvSpPr>
        <cdr:spPr>
          <a:xfrm xmlns:a="http://schemas.openxmlformats.org/drawingml/2006/main">
            <a:off x="5508104" y="980728"/>
            <a:ext cx="1112447" cy="5400600"/>
          </a:xfrm>
          <a:prstGeom xmlns:a="http://schemas.openxmlformats.org/drawingml/2006/main" prst="rect">
            <a:avLst/>
          </a:prstGeom>
          <a:solidFill xmlns:a="http://schemas.openxmlformats.org/drawingml/2006/main">
            <a:sysClr val="window" lastClr="FFFFFF"/>
          </a:solidFill>
          <a:ln xmlns:a="http://schemas.openxmlformats.org/drawingml/2006/main" w="25400" cap="flat" cmpd="sng" algn="ctr">
            <a:solidFill>
              <a:sysClr val="window" lastClr="FFFFFF"/>
            </a:solidFill>
            <a:prstDash val="solid"/>
          </a:ln>
          <a:effectLst xmlns:a="http://schemas.openxmlformats.org/drawingml/2006/main"/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9pPr>
          </a:lstStyle>
          <a:p xmlns:a="http://schemas.openxmlformats.org/drawingml/2006/main">
            <a:endParaRPr lang="en-US"/>
          </a:p>
        </cdr:txBody>
      </cdr:sp>
      <cdr:sp macro="" textlink="">
        <cdr:nvSpPr>
          <cdr:cNvPr id="11" name="TextBox 2"/>
          <cdr:cNvSpPr txBox="1"/>
        </cdr:nvSpPr>
        <cdr:spPr>
          <a:xfrm xmlns:a="http://schemas.openxmlformats.org/drawingml/2006/main">
            <a:off x="5580112" y="1268760"/>
            <a:ext cx="1150756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Very severe</a:t>
            </a:r>
            <a:endParaRPr lang="en-AU" sz="1600" dirty="0"/>
          </a:p>
        </cdr:txBody>
      </cdr:sp>
      <cdr:sp macro="" textlink="">
        <cdr:nvSpPr>
          <cdr:cNvPr id="12" name="TextBox 3"/>
          <cdr:cNvSpPr txBox="1"/>
        </cdr:nvSpPr>
        <cdr:spPr>
          <a:xfrm xmlns:a="http://schemas.openxmlformats.org/drawingml/2006/main">
            <a:off x="5902721" y="2492896"/>
            <a:ext cx="744303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/>
              <a:t>S</a:t>
            </a:r>
            <a:r>
              <a:rPr lang="en-AU" sz="1600" dirty="0" smtClean="0"/>
              <a:t>evere</a:t>
            </a:r>
            <a:endParaRPr lang="en-AU" sz="1600" dirty="0"/>
          </a:p>
        </cdr:txBody>
      </cdr:sp>
      <cdr:sp macro="" textlink="">
        <cdr:nvSpPr>
          <cdr:cNvPr id="13" name="TextBox 4"/>
          <cdr:cNvSpPr txBox="1"/>
        </cdr:nvSpPr>
        <cdr:spPr>
          <a:xfrm xmlns:a="http://schemas.openxmlformats.org/drawingml/2006/main">
            <a:off x="5759114" y="3573016"/>
            <a:ext cx="1008622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Moderate</a:t>
            </a:r>
            <a:endParaRPr lang="en-AU" sz="1600" dirty="0"/>
          </a:p>
        </cdr:txBody>
      </cdr:sp>
      <cdr:sp macro="" textlink="">
        <cdr:nvSpPr>
          <cdr:cNvPr id="14" name="TextBox 6"/>
          <cdr:cNvSpPr txBox="1"/>
        </cdr:nvSpPr>
        <cdr:spPr>
          <a:xfrm xmlns:a="http://schemas.openxmlformats.org/drawingml/2006/main">
            <a:off x="6118131" y="4725144"/>
            <a:ext cx="558179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Mild</a:t>
            </a:r>
            <a:endParaRPr lang="en-AU" sz="1600" dirty="0"/>
          </a:p>
        </cdr:txBody>
      </cdr:sp>
      <cdr:sp macro="" textlink="">
        <cdr:nvSpPr>
          <cdr:cNvPr id="15" name="TextBox 7"/>
          <cdr:cNvSpPr txBox="1"/>
        </cdr:nvSpPr>
        <cdr:spPr>
          <a:xfrm xmlns:a="http://schemas.openxmlformats.org/drawingml/2006/main">
            <a:off x="6046328" y="5805264"/>
            <a:ext cx="634904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None</a:t>
            </a:r>
            <a:endParaRPr lang="en-AU" sz="1600" dirty="0"/>
          </a:p>
        </cdr:txBody>
      </cdr:sp>
    </cdr:grp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/>
          <p:nvPr/>
        </p:nvGraphicFramePr>
        <p:xfrm>
          <a:off x="0" y="404664"/>
          <a:ext cx="9144000" cy="6453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3" name="Group 12"/>
          <p:cNvGrpSpPr/>
          <p:nvPr/>
        </p:nvGrpSpPr>
        <p:grpSpPr>
          <a:xfrm>
            <a:off x="516100" y="72008"/>
            <a:ext cx="1175580" cy="6021288"/>
            <a:chOff x="1331640" y="908720"/>
            <a:chExt cx="1175580" cy="5400600"/>
          </a:xfrm>
        </p:grpSpPr>
        <p:sp>
          <p:nvSpPr>
            <p:cNvPr id="14" name="Rectangle 13"/>
            <p:cNvSpPr/>
            <p:nvPr/>
          </p:nvSpPr>
          <p:spPr>
            <a:xfrm>
              <a:off x="1331640" y="908720"/>
              <a:ext cx="1112447" cy="5400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475656" y="1196752"/>
              <a:ext cx="1031564" cy="5244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AU" sz="1600" dirty="0" smtClean="0"/>
                <a:t>Strenuous</a:t>
              </a:r>
            </a:p>
            <a:p>
              <a:pPr algn="r"/>
              <a:r>
                <a:rPr lang="en-AU" sz="1600" dirty="0" smtClean="0"/>
                <a:t>labour </a:t>
              </a:r>
              <a:endParaRPr lang="en-AU" sz="16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450136" y="2627961"/>
              <a:ext cx="1011494" cy="5244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AU" sz="1600" dirty="0" smtClean="0"/>
                <a:t>Moderate</a:t>
              </a:r>
            </a:p>
            <a:p>
              <a:pPr algn="r"/>
              <a:r>
                <a:rPr lang="en-AU" sz="1600" dirty="0" smtClean="0"/>
                <a:t>Activity</a:t>
              </a:r>
              <a:endParaRPr lang="en-AU" sz="16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643124" y="4242592"/>
              <a:ext cx="813043" cy="5244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AU" sz="1600" dirty="0" smtClean="0"/>
                <a:t>Light </a:t>
              </a:r>
            </a:p>
            <a:p>
              <a:pPr algn="r"/>
              <a:r>
                <a:rPr lang="en-AU" sz="1600" dirty="0" smtClean="0"/>
                <a:t>Activity</a:t>
              </a:r>
              <a:endParaRPr lang="en-AU" sz="16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798499" y="5921808"/>
              <a:ext cx="636713" cy="3036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AU" sz="1600" dirty="0" smtClean="0"/>
                <a:t>None</a:t>
              </a:r>
              <a:endParaRPr lang="en-AU" sz="1600" dirty="0"/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2003128" y="5898758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  <p:grpSp>
        <p:nvGrpSpPr>
          <p:cNvPr id="10" name="Group 9"/>
          <p:cNvGrpSpPr/>
          <p:nvPr/>
        </p:nvGrpSpPr>
        <p:grpSpPr>
          <a:xfrm>
            <a:off x="2411760" y="3059668"/>
            <a:ext cx="1440160" cy="144016"/>
            <a:chOff x="3707904" y="3068960"/>
            <a:chExt cx="2736304" cy="144016"/>
          </a:xfrm>
        </p:grpSpPr>
        <p:cxnSp>
          <p:nvCxnSpPr>
            <p:cNvPr id="11" name="Straight Connector 10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Group 20"/>
          <p:cNvGrpSpPr/>
          <p:nvPr/>
        </p:nvGrpSpPr>
        <p:grpSpPr>
          <a:xfrm>
            <a:off x="2411760" y="2646204"/>
            <a:ext cx="2808312" cy="144016"/>
            <a:chOff x="3707904" y="3068960"/>
            <a:chExt cx="2736304" cy="144016"/>
          </a:xfrm>
        </p:grpSpPr>
        <p:cxnSp>
          <p:nvCxnSpPr>
            <p:cNvPr id="22" name="Straight Connector 21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" name="Group 33"/>
          <p:cNvGrpSpPr/>
          <p:nvPr/>
        </p:nvGrpSpPr>
        <p:grpSpPr>
          <a:xfrm>
            <a:off x="3923928" y="3923764"/>
            <a:ext cx="1368152" cy="144016"/>
            <a:chOff x="3707904" y="3068960"/>
            <a:chExt cx="2736304" cy="144016"/>
          </a:xfrm>
        </p:grpSpPr>
        <p:cxnSp>
          <p:nvCxnSpPr>
            <p:cNvPr id="35" name="Straight Connector 34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" name="Group 37"/>
          <p:cNvGrpSpPr/>
          <p:nvPr/>
        </p:nvGrpSpPr>
        <p:grpSpPr>
          <a:xfrm>
            <a:off x="5292080" y="3438292"/>
            <a:ext cx="1440160" cy="134724"/>
            <a:chOff x="3707904" y="3068960"/>
            <a:chExt cx="2736304" cy="144016"/>
          </a:xfrm>
        </p:grpSpPr>
        <p:cxnSp>
          <p:nvCxnSpPr>
            <p:cNvPr id="39" name="Straight Connector 38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6" name="TextBox 45"/>
          <p:cNvSpPr txBox="1"/>
          <p:nvPr/>
        </p:nvSpPr>
        <p:spPr>
          <a:xfrm>
            <a:off x="2843808" y="2843644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47" name="TextBox 46"/>
          <p:cNvSpPr txBox="1"/>
          <p:nvPr/>
        </p:nvSpPr>
        <p:spPr>
          <a:xfrm>
            <a:off x="5796136" y="3212976"/>
            <a:ext cx="680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**</a:t>
            </a:r>
            <a:endParaRPr lang="en-AU" dirty="0"/>
          </a:p>
        </p:txBody>
      </p:sp>
      <p:sp>
        <p:nvSpPr>
          <p:cNvPr id="49" name="TextBox 48"/>
          <p:cNvSpPr txBox="1"/>
          <p:nvPr/>
        </p:nvSpPr>
        <p:spPr>
          <a:xfrm>
            <a:off x="3695854" y="2420888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52" name="TextBox 51"/>
          <p:cNvSpPr txBox="1"/>
          <p:nvPr/>
        </p:nvSpPr>
        <p:spPr>
          <a:xfrm>
            <a:off x="4283968" y="3707740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/>
          <p:nvPr/>
        </p:nvGraphicFramePr>
        <p:xfrm>
          <a:off x="0" y="404664"/>
          <a:ext cx="9144000" cy="6453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 12"/>
          <p:cNvGrpSpPr/>
          <p:nvPr/>
        </p:nvGrpSpPr>
        <p:grpSpPr>
          <a:xfrm>
            <a:off x="516100" y="72008"/>
            <a:ext cx="1175580" cy="6021288"/>
            <a:chOff x="1331640" y="908720"/>
            <a:chExt cx="1175580" cy="5400600"/>
          </a:xfrm>
        </p:grpSpPr>
        <p:sp>
          <p:nvSpPr>
            <p:cNvPr id="14" name="Rectangle 13"/>
            <p:cNvSpPr/>
            <p:nvPr/>
          </p:nvSpPr>
          <p:spPr>
            <a:xfrm>
              <a:off x="1331640" y="908720"/>
              <a:ext cx="1112447" cy="5400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475656" y="1196752"/>
              <a:ext cx="1031564" cy="5244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AU" sz="1600" dirty="0" smtClean="0"/>
                <a:t>Strenuous</a:t>
              </a:r>
            </a:p>
            <a:p>
              <a:pPr algn="r"/>
              <a:r>
                <a:rPr lang="en-AU" sz="1600" dirty="0" smtClean="0"/>
                <a:t>labour </a:t>
              </a:r>
              <a:endParaRPr lang="en-AU" sz="16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450136" y="2627961"/>
              <a:ext cx="1011494" cy="5244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AU" sz="1600" dirty="0" smtClean="0"/>
                <a:t>Moderate</a:t>
              </a:r>
            </a:p>
            <a:p>
              <a:pPr algn="r"/>
              <a:r>
                <a:rPr lang="en-AU" sz="1600" dirty="0" smtClean="0"/>
                <a:t>Activity</a:t>
              </a:r>
              <a:endParaRPr lang="en-AU" sz="16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643124" y="4242592"/>
              <a:ext cx="813043" cy="5244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AU" sz="1600" dirty="0" smtClean="0"/>
                <a:t>Light </a:t>
              </a:r>
            </a:p>
            <a:p>
              <a:pPr algn="r"/>
              <a:r>
                <a:rPr lang="en-AU" sz="1600" dirty="0" smtClean="0"/>
                <a:t>Activity</a:t>
              </a:r>
              <a:endParaRPr lang="en-AU" sz="16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798499" y="5921808"/>
              <a:ext cx="636713" cy="3036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AU" sz="1600" dirty="0" smtClean="0"/>
                <a:t>None</a:t>
              </a:r>
              <a:endParaRPr lang="en-AU" sz="1600" dirty="0"/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2003128" y="5898758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/>
          <p:cNvGraphicFramePr/>
          <p:nvPr/>
        </p:nvGraphicFramePr>
        <p:xfrm>
          <a:off x="-24681" y="0"/>
          <a:ext cx="9168681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755576" y="620688"/>
            <a:ext cx="2074564" cy="5400600"/>
            <a:chOff x="1331640" y="908720"/>
            <a:chExt cx="2074564" cy="5400600"/>
          </a:xfrm>
        </p:grpSpPr>
        <p:sp>
          <p:nvSpPr>
            <p:cNvPr id="10" name="Rectangle 9"/>
            <p:cNvSpPr/>
            <p:nvPr/>
          </p:nvSpPr>
          <p:spPr>
            <a:xfrm>
              <a:off x="1331640" y="908720"/>
              <a:ext cx="1112447" cy="5400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1403648" y="1196752"/>
              <a:ext cx="166475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Strenuous labour </a:t>
              </a:r>
              <a:endParaRPr lang="en-AU" sz="1600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726257" y="2420888"/>
              <a:ext cx="16799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oderate Activity</a:t>
              </a:r>
              <a:endParaRPr lang="en-AU" sz="1600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582650" y="3501008"/>
              <a:ext cx="12567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Light Activity</a:t>
              </a:r>
              <a:endParaRPr lang="en-AU" sz="16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941667" y="4653136"/>
              <a:ext cx="6367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None</a:t>
              </a:r>
              <a:endParaRPr lang="en-AU" sz="1600" dirty="0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3853292" y="1061120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57</Words>
  <Application>Microsoft Office PowerPoint</Application>
  <PresentationFormat>On-screen Show (4:3)</PresentationFormat>
  <Paragraphs>31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t</dc:creator>
  <cp:lastModifiedBy>Pat</cp:lastModifiedBy>
  <cp:revision>13</cp:revision>
  <dcterms:created xsi:type="dcterms:W3CDTF">2011-11-19T23:44:44Z</dcterms:created>
  <dcterms:modified xsi:type="dcterms:W3CDTF">2012-01-17T00:24:46Z</dcterms:modified>
</cp:coreProperties>
</file>